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ng, Yuyang" userId="624bfbdb-7781-46f6-b49b-a5fb0dad298f" providerId="ADAL" clId="{DAE94F5E-632E-4557-88F5-39BCFCAC6C60}"/>
    <pc:docChg chg="modSld">
      <pc:chgData name="Tang, Yuyang" userId="624bfbdb-7781-46f6-b49b-a5fb0dad298f" providerId="ADAL" clId="{DAE94F5E-632E-4557-88F5-39BCFCAC6C60}" dt="2025-07-30T14:45:06.441" v="3" actId="20577"/>
      <pc:docMkLst>
        <pc:docMk/>
      </pc:docMkLst>
      <pc:sldChg chg="modSp mod">
        <pc:chgData name="Tang, Yuyang" userId="624bfbdb-7781-46f6-b49b-a5fb0dad298f" providerId="ADAL" clId="{DAE94F5E-632E-4557-88F5-39BCFCAC6C60}" dt="2025-07-30T14:45:06.441" v="3" actId="20577"/>
        <pc:sldMkLst>
          <pc:docMk/>
          <pc:sldMk cId="1869832774" sldId="278"/>
        </pc:sldMkLst>
        <pc:spChg chg="mod">
          <ac:chgData name="Tang, Yuyang" userId="624bfbdb-7781-46f6-b49b-a5fb0dad298f" providerId="ADAL" clId="{DAE94F5E-632E-4557-88F5-39BCFCAC6C60}" dt="2025-07-30T14:45:06.441" v="3" actId="20577"/>
          <ac:spMkLst>
            <pc:docMk/>
            <pc:sldMk cId="1869832774" sldId="278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FF04A-832C-70E1-7C35-D7C58FC41A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0F4B18-9301-F0F2-BBDA-56669BA047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768CF0-BA7D-E582-A1DF-CAC158E95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4A98A9-5AAA-099E-5672-F0EAEE3BB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EA3ACA-F46F-6AD4-0255-4CFD50905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712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5A12-2491-A849-3EE2-D4C51B2D46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F150EA-FB31-7E9B-84D9-1E3235237B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7BC77-9892-48C8-2D36-C27134B8E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2770C9-4745-F44F-20B3-AFC46CD50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D9EA93-9FDF-2CBE-387A-58FA70838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589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B75793-3DF5-06A0-3DD3-FC2CCD7F28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49024F-869B-EE62-87FE-7F06901F2A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1A620C-5B93-9864-579E-9F8D672E5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A7ED8E-9A64-FDC8-B5D1-BAB09B10A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A167E-E634-E133-B639-E2FD1997C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901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CC07F7-37F9-A173-F3E8-2B6775BBD7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885FD7-4A5D-88DB-127F-FB612F4E1E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C0B528-243A-4BA1-4B24-2C9A4DE26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6F58F-AEF7-2921-A926-5E99637B2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29F80-CAF8-84A6-8738-1D4437A43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004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F3A324-12FF-5336-5F1D-4A4133059A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910FCF-14FB-7AC2-A5F4-486FA87311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DCB61B-3E5A-20FA-BB4B-94F99B7BF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948B7-6684-7BA0-3D19-61FCA348D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EAD6C0-4C4C-A81F-2CC8-0178F9B6D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48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18E672-DBDE-350D-2512-CB56D54729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3F25A7-3403-A339-982F-ED34FA5BE1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79D35A-C7E7-E5C4-D328-0D9B38CC30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F87FFA-16DC-97E4-8BCB-25A73DD0F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091CA2-10CF-5616-468F-96E880069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70CBC6-9460-36A1-56C2-6941B4ED7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477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69B214-412E-DF09-1219-D1CD56CCA8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491ACF-F117-D4B5-F706-9CEFFB0DC2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88BB2E-CB42-592E-9F20-5EBC95766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EBDA7A-5230-8371-4789-1F29583BA1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3664A9-5A35-58B0-84E3-E60C4A8EA0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00D1AE-9A7B-57A5-16BD-17B4BAA6B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349B52-A72C-2696-C6E5-303B691AF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C273E3-4D98-8F99-D529-D3D72841C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391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3A671-DB77-F2A7-9EC9-B983FB06C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59B51E-5C82-23D2-F0F0-0EA72392B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B6AA52-015A-69B0-AE7E-7ED17CB9F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7835CB-5F3E-56A4-3E28-23D130897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599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B9E3BD-B867-B7F9-93C7-1A880465A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BE11B8-7FD4-4853-2DA7-690B13625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64E7D1-F3AA-7EAA-805C-A12D3FEAD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983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81F51A-62D4-6632-C273-04DE0EC07F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BE9E8C-A7CB-FAD6-2D73-7265D310A1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ED394F-A774-0EF7-8E11-048A8BA94B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BCFF01-6A19-11F0-6C02-50B7C87D6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127E46-6166-E239-FCDE-10E474969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A52C6B-EACB-E332-EA36-61E184008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397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5704D-27D7-FD3C-3FA7-AF62F317A6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9AC39E-4473-E5C2-FDC6-C78AF1DADE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D0E8F1-5F8E-02EA-0A9F-65EAC1BC29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0B9EEB-25A7-3B0E-A836-626E49B36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ECA271-525E-3A0C-0733-EDCEC78E6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9845FF-9052-D439-5C9D-0A82DD2AF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704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3797D2-3B0C-E4A4-5BE4-C976A15B88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80BA4D-AAFE-23DD-2E46-B415C83774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C38717-1120-FC76-3940-E3719F5292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C2C2D2-772A-4A31-9C74-A361EC0532F8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DFEB32-4E76-4DB5-F63E-15470C4214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10D34-CD0D-7AD4-E306-F270C43AA1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CEEF91-3092-4B82-93D2-65C18C82A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269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895286" y="1719516"/>
          <a:ext cx="5268451" cy="2533767"/>
        </p:xfrm>
        <a:graphic>
          <a:graphicData uri="http://schemas.openxmlformats.org/drawingml/2006/table">
            <a:tbl>
              <a:tblPr/>
              <a:tblGrid>
                <a:gridCol w="1198007">
                  <a:extLst>
                    <a:ext uri="{9D8B030D-6E8A-4147-A177-3AD203B41FA5}">
                      <a16:colId xmlns:a16="http://schemas.microsoft.com/office/drawing/2014/main" val="1465547397"/>
                    </a:ext>
                  </a:extLst>
                </a:gridCol>
                <a:gridCol w="1017611">
                  <a:extLst>
                    <a:ext uri="{9D8B030D-6E8A-4147-A177-3AD203B41FA5}">
                      <a16:colId xmlns:a16="http://schemas.microsoft.com/office/drawing/2014/main" val="272894615"/>
                    </a:ext>
                  </a:extLst>
                </a:gridCol>
                <a:gridCol w="1017611">
                  <a:extLst>
                    <a:ext uri="{9D8B030D-6E8A-4147-A177-3AD203B41FA5}">
                      <a16:colId xmlns:a16="http://schemas.microsoft.com/office/drawing/2014/main" val="2864744861"/>
                    </a:ext>
                  </a:extLst>
                </a:gridCol>
                <a:gridCol w="1017611">
                  <a:extLst>
                    <a:ext uri="{9D8B030D-6E8A-4147-A177-3AD203B41FA5}">
                      <a16:colId xmlns:a16="http://schemas.microsoft.com/office/drawing/2014/main" val="1301929448"/>
                    </a:ext>
                  </a:extLst>
                </a:gridCol>
                <a:gridCol w="1017611">
                  <a:extLst>
                    <a:ext uri="{9D8B030D-6E8A-4147-A177-3AD203B41FA5}">
                      <a16:colId xmlns:a16="http://schemas.microsoft.com/office/drawing/2014/main" val="1822248489"/>
                    </a:ext>
                  </a:extLst>
                </a:gridCol>
              </a:tblGrid>
              <a:tr h="29141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a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4180684"/>
                  </a:ext>
                </a:extLst>
              </a:tr>
              <a:tr h="2779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-AN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-AN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1078372"/>
                  </a:ext>
                </a:extLst>
              </a:tr>
              <a:tr h="23036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AP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901980"/>
                  </a:ext>
                </a:extLst>
              </a:tr>
              <a:tr h="23975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XDC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41134"/>
                  </a:ext>
                </a:extLst>
              </a:tr>
              <a:tr h="250902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M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378426"/>
                  </a:ext>
                </a:extLst>
              </a:tr>
              <a:tr h="23417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5987761"/>
                  </a:ext>
                </a:extLst>
              </a:tr>
              <a:tr h="250902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A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64588"/>
                  </a:ext>
                </a:extLst>
              </a:tr>
              <a:tr h="24532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124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8810836"/>
                  </a:ext>
                </a:extLst>
              </a:tr>
              <a:tr h="25090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R1L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4419308"/>
                  </a:ext>
                </a:extLst>
              </a:tr>
              <a:tr h="26205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N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8207999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816590" y="1442517"/>
            <a:ext cx="57068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2. Non-immune related factors are upregulated in the HAND brain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A83304-DC77-1765-7160-B792B38F2F7B}"/>
              </a:ext>
            </a:extLst>
          </p:cNvPr>
          <p:cNvSpPr txBox="1"/>
          <p:nvPr/>
        </p:nvSpPr>
        <p:spPr>
          <a:xfrm flipH="1">
            <a:off x="1816589" y="4253283"/>
            <a:ext cx="3457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te: The data represent Log2 ratio to control.</a:t>
            </a:r>
          </a:p>
        </p:txBody>
      </p:sp>
    </p:spTree>
    <p:extLst>
      <p:ext uri="{BB962C8B-B14F-4D97-AF65-F5344CB8AC3E}">
        <p14:creationId xmlns:p14="http://schemas.microsoft.com/office/powerpoint/2010/main" val="1869832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6:25Z</dcterms:created>
  <dcterms:modified xsi:type="dcterms:W3CDTF">2025-07-30T14:45:11Z</dcterms:modified>
</cp:coreProperties>
</file>